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5B018E-ACD9-4F5A-9F5D-9D2EC4ACDE7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DA7EB0-E634-4709-9056-2478E6A831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63B9C0-022F-4E8F-A00E-7A98C3B8E94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6402E0-F04B-4355-BCF3-363CF771E02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ADC6BE-3D84-400C-BDCA-116E1A20C2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8072AE-8627-4513-9CE3-B71BE0A2C7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4677A4-7AE0-420E-82D6-009E184F0D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6717CF-A63C-430C-8377-DC64EB7357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7681A8-2DCC-40CC-9173-C8D09F88E6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F1331C-A5D0-42FC-9CB3-C70FF29360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D437DE-4D6C-4E82-924B-2CB35839BB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E88155-C7EA-48AA-B98C-BEAAEB4E8B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A5CF7EC-39FE-4CD5-98FC-A2E1EF17BFD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11240" y="3728880"/>
          <a:ext cx="6159240" cy="1824120"/>
        </p:xfrm>
        <a:graphic>
          <a:graphicData uri="http://schemas.openxmlformats.org/drawingml/2006/table">
            <a:tbl>
              <a:tblPr/>
              <a:tblGrid>
                <a:gridCol w="825480"/>
                <a:gridCol w="1003320"/>
                <a:gridCol w="963360"/>
                <a:gridCol w="700200"/>
                <a:gridCol w="863640"/>
                <a:gridCol w="901800"/>
                <a:gridCol w="901440"/>
              </a:tblGrid>
              <a:tr h="439920">
                <a:tc gridSpan="7"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mparison of means of FOXA1 methylation between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M</a:t>
                      </a:r>
                      <a:r>
                        <a:rPr b="1" lang="en-US" sz="14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</a:rPr>
                        <a:t>&lt;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an and GEM&gt;mean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030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6"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roup Statistic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06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a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d. Devi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d. Error Mea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812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A1 methyl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M≤mea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9348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M&gt;mea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0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6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8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282600" y="5923080"/>
          <a:ext cx="6391080" cy="2533680"/>
        </p:xfrm>
        <a:graphic>
          <a:graphicData uri="http://schemas.openxmlformats.org/drawingml/2006/table">
            <a:tbl>
              <a:tblPr/>
              <a:tblGrid>
                <a:gridCol w="747720"/>
                <a:gridCol w="685800"/>
                <a:gridCol w="482400"/>
                <a:gridCol w="474840"/>
                <a:gridCol w="488880"/>
                <a:gridCol w="546120"/>
                <a:gridCol w="515880"/>
                <a:gridCol w="642960"/>
                <a:gridCol w="692280"/>
                <a:gridCol w="577800"/>
                <a:gridCol w="536400"/>
              </a:tblGrid>
              <a:tr h="179280">
                <a:tc gridSpan="11">
                  <a:txBody>
                    <a:bodyPr lIns="11160" rIns="11160" tIns="11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dependent Samples Tes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68360">
                <a:tc gridSpan="2" rowSpan="3">
                  <a:txBody>
                    <a:bodyPr lIns="11160" rIns="11160" tIns="11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11160" rIns="11160" tIns="11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evene's Test for Equality of Varianc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7">
                  <a:txBody>
                    <a:bodyPr lIns="11160" rIns="11160" tIns="11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-test for Equality of Mea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504720"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11160" rIns="11160" tIns="11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 lIns="11160" rIns="11160" tIns="11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.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 lIns="11160" rIns="11160" tIns="11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 lIns="11160" rIns="11160" tIns="11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 lIns="11160" rIns="11160" tIns="11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. (2-tailed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 lIns="11160" rIns="11160" tIns="11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an Differen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 lIns="11160" rIns="11160" tIns="11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d. Error Differen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11160" rIns="11160" tIns="11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% Confidence Interval of the Differen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79280"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ow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pp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17680">
                <a:tc rowSpan="2">
                  <a:txBody>
                    <a:bodyPr lIns="11160" rIns="11160" tIns="11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A1 methyl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qual variances assum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8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684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qual variances not assum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6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.95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8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1160" rIns="11160" tIns="111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fld id="{733FAEDF-F766-4BD8-ADB2-5551C6496B87}" type="slidenum"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number&gt;</a:t>
                      </a:fld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1160" marR="111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976320" y="1581120"/>
          <a:ext cx="4470480" cy="1400040"/>
        </p:xfrm>
        <a:graphic>
          <a:graphicData uri="http://schemas.openxmlformats.org/drawingml/2006/table">
            <a:tbl>
              <a:tblPr/>
              <a:tblGrid>
                <a:gridCol w="1333440"/>
                <a:gridCol w="1181160"/>
                <a:gridCol w="1130400"/>
                <a:gridCol w="825480"/>
              </a:tblGrid>
              <a:tr h="195120">
                <a:tc gridSpan="4"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atistic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06440">
                <a:tc gridSpan="2"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A1 methyl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A1 express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03400">
                <a:tc rowSpan="2"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ali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69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ss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5120">
                <a:tc gridSpan="2"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a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.50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3040">
                <a:tc gridSpan="2"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dia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.22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4" name="TextBox 22"/>
          <p:cNvSpPr/>
          <p:nvPr/>
        </p:nvSpPr>
        <p:spPr>
          <a:xfrm>
            <a:off x="994320" y="1219320"/>
            <a:ext cx="4548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eans of FOXA1 methylation and expression level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23"/>
          <p:cNvSpPr/>
          <p:nvPr/>
        </p:nvSpPr>
        <p:spPr>
          <a:xfrm>
            <a:off x="186120" y="93204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24"/>
          <p:cNvSpPr/>
          <p:nvPr/>
        </p:nvSpPr>
        <p:spPr>
          <a:xfrm>
            <a:off x="197640" y="3425760"/>
            <a:ext cx="3664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7"/>
          <p:cNvSpPr/>
          <p:nvPr/>
        </p:nvSpPr>
        <p:spPr>
          <a:xfrm>
            <a:off x="5080680" y="9609120"/>
            <a:ext cx="178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 S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16T23:48:49Z</dcterms:created>
  <dc:creator>Jade Gong</dc:creator>
  <dc:description/>
  <dc:language>en-US</dc:language>
  <cp:lastModifiedBy>Eric Lam</cp:lastModifiedBy>
  <cp:lastPrinted>2014-09-26T09:57:40Z</cp:lastPrinted>
  <dcterms:modified xsi:type="dcterms:W3CDTF">2014-10-01T11:26:53Z</dcterms:modified>
  <cp:revision>591</cp:revision>
  <dc:subject/>
  <dc:title>PowerPoint Presentation</dc:title>
</cp:coreProperties>
</file>